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ABB8AA-F65A-425C-8F31-AB54CE586BFE}" type="slidenum">
              <a:rPr b="0" lang="en-NZ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0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0F9AF4-07C9-4A9E-805E-4C04DC85F7B6}" type="slidenum">
              <a:rPr b="0" lang="en-NZ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378D8C-9A62-4061-A13A-FCC9C681EE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9408F-D46B-4233-9BBE-0E5E117AEA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4E691-5C44-44E9-9EE9-A6ECE815B0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F73F9-3A19-4AC4-ACC6-A923BB5DE4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9DBF52-1DF1-4D77-AEAF-497A1BBBC9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4A900-1CD7-4B35-ACBA-C8C520CD54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72138-FEDA-431B-A93E-D64EDC282F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B9875-E315-45DD-83BA-D13CB4BFDB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B8980-3C05-4306-8ECE-2980DAF2BC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CF0F7-C49C-40FC-BC2D-198F9F713D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29EB2-21AF-42DB-9063-E518B1B10A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50E68-3322-4285-BEE0-D0762D773D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EC135C-5275-4685-B14C-6E36E0A11AC1}" type="slidenum">
              <a:rPr b="0" lang="en-NZ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2"/>
          <p:cNvGraphicFramePr/>
          <p:nvPr/>
        </p:nvGraphicFramePr>
        <p:xfrm>
          <a:off x="249120" y="625320"/>
          <a:ext cx="2160720" cy="1981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49120" y="625320"/>
                    <a:ext cx="2160720" cy="198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Box 243"/>
          <p:cNvSpPr/>
          <p:nvPr/>
        </p:nvSpPr>
        <p:spPr>
          <a:xfrm flipH="1" rot="16200000">
            <a:off x="-145080" y="1339200"/>
            <a:ext cx="87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% incre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1" name="Object 3"/>
          <p:cNvGraphicFramePr/>
          <p:nvPr/>
        </p:nvGraphicFramePr>
        <p:xfrm>
          <a:off x="2427120" y="625320"/>
          <a:ext cx="2187720" cy="20019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2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427120" y="625320"/>
                    <a:ext cx="2187720" cy="2001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53" name="Group 74"/>
          <p:cNvGrpSpPr/>
          <p:nvPr/>
        </p:nvGrpSpPr>
        <p:grpSpPr>
          <a:xfrm>
            <a:off x="4722840" y="631800"/>
            <a:ext cx="1803600" cy="1673280"/>
            <a:chOff x="4722840" y="631800"/>
            <a:chExt cx="1803600" cy="1673280"/>
          </a:xfrm>
        </p:grpSpPr>
        <p:graphicFrame>
          <p:nvGraphicFramePr>
            <p:cNvPr id="54" name="Object 59"/>
            <p:cNvGraphicFramePr/>
            <p:nvPr/>
          </p:nvGraphicFramePr>
          <p:xfrm>
            <a:off x="4722840" y="676080"/>
            <a:ext cx="1693800" cy="162900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5" name="Object 59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4722840" y="676080"/>
                      <a:ext cx="1693800" cy="1629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6" name="Straight Connector 6"/>
            <p:cNvSpPr/>
            <p:nvPr/>
          </p:nvSpPr>
          <p:spPr>
            <a:xfrm>
              <a:off x="5691240" y="853920"/>
              <a:ext cx="7920" cy="1371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94"/>
            <p:cNvSpPr/>
            <p:nvPr/>
          </p:nvSpPr>
          <p:spPr>
            <a:xfrm>
              <a:off x="5826240" y="1073160"/>
              <a:ext cx="42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ight Bracket 8"/>
            <p:cNvSpPr/>
            <p:nvPr/>
          </p:nvSpPr>
          <p:spPr>
            <a:xfrm rot="16200000">
              <a:off x="5976000" y="1144800"/>
              <a:ext cx="83880" cy="317520"/>
            </a:xfrm>
            <a:custGeom>
              <a:avLst/>
              <a:gdLst>
                <a:gd name="textAreaLeft" fmla="*/ 0 w 83880"/>
                <a:gd name="textAreaRight" fmla="*/ 59040 w 83880"/>
                <a:gd name="textAreaTop" fmla="*/ 3240 h 317520"/>
                <a:gd name="textAreaBottom" fmla="*/ 314280 h 3175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239"/>
                    <a:pt x="21600" y="477"/>
                  </a:cubicBezTo>
                  <a:lnTo>
                    <a:pt x="21600" y="21123"/>
                  </a:lnTo>
                  <a:cubicBezTo>
                    <a:pt x="21600" y="21362"/>
                    <a:pt x="10800" y="21600"/>
                    <a:pt x="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94"/>
            <p:cNvSpPr/>
            <p:nvPr/>
          </p:nvSpPr>
          <p:spPr>
            <a:xfrm>
              <a:off x="5234400" y="814320"/>
              <a:ext cx="22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ight Bracket 10"/>
            <p:cNvSpPr/>
            <p:nvPr/>
          </p:nvSpPr>
          <p:spPr>
            <a:xfrm rot="16200000">
              <a:off x="5337720" y="849960"/>
              <a:ext cx="55440" cy="365040"/>
            </a:xfrm>
            <a:custGeom>
              <a:avLst/>
              <a:gdLst>
                <a:gd name="textAreaLeft" fmla="*/ 0 w 55440"/>
                <a:gd name="textAreaRight" fmla="*/ 38880 w 55440"/>
                <a:gd name="textAreaTop" fmla="*/ 2160 h 365040"/>
                <a:gd name="textAreaBottom" fmla="*/ 362880 h 365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37"/>
                    <a:pt x="21600" y="274"/>
                  </a:cubicBezTo>
                  <a:lnTo>
                    <a:pt x="21600" y="21326"/>
                  </a:lnTo>
                  <a:cubicBezTo>
                    <a:pt x="21600" y="21463"/>
                    <a:pt x="10800" y="21600"/>
                    <a:pt x="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68"/>
            <p:cNvSpPr/>
            <p:nvPr/>
          </p:nvSpPr>
          <p:spPr>
            <a:xfrm>
              <a:off x="4870440" y="631800"/>
              <a:ext cx="165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</a:t>
              </a: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T549    MDA-MB-23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TextBox 41"/>
          <p:cNvSpPr/>
          <p:nvPr/>
        </p:nvSpPr>
        <p:spPr>
          <a:xfrm>
            <a:off x="4549320" y="344520"/>
            <a:ext cx="194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Colony formation in soft ag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34"/>
          <p:cNvSpPr/>
          <p:nvPr/>
        </p:nvSpPr>
        <p:spPr>
          <a:xfrm>
            <a:off x="231480" y="344520"/>
            <a:ext cx="162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Monolayer prolifer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7"/>
          <p:cNvSpPr/>
          <p:nvPr/>
        </p:nvSpPr>
        <p:spPr>
          <a:xfrm>
            <a:off x="4335120" y="3445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7"/>
          <p:cNvSpPr/>
          <p:nvPr/>
        </p:nvSpPr>
        <p:spPr>
          <a:xfrm>
            <a:off x="47160" y="3445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3"/>
          <p:cNvSpPr/>
          <p:nvPr/>
        </p:nvSpPr>
        <p:spPr>
          <a:xfrm>
            <a:off x="1389960" y="1568520"/>
            <a:ext cx="59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BT549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3"/>
          <p:cNvSpPr/>
          <p:nvPr/>
        </p:nvSpPr>
        <p:spPr>
          <a:xfrm>
            <a:off x="3322080" y="1568520"/>
            <a:ext cx="99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MDA-MB-23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 167"/>
          <p:cNvGrpSpPr/>
          <p:nvPr/>
        </p:nvGrpSpPr>
        <p:grpSpPr>
          <a:xfrm>
            <a:off x="5880240" y="812880"/>
            <a:ext cx="806400" cy="399960"/>
            <a:chOff x="5880240" y="812880"/>
            <a:chExt cx="806400" cy="399960"/>
          </a:xfrm>
        </p:grpSpPr>
        <p:sp>
          <p:nvSpPr>
            <p:cNvPr id="69" name="Rectangle 51"/>
            <p:cNvSpPr/>
            <p:nvPr/>
          </p:nvSpPr>
          <p:spPr>
            <a:xfrm>
              <a:off x="5880240" y="895320"/>
              <a:ext cx="144360" cy="7128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52"/>
            <p:cNvSpPr/>
            <p:nvPr/>
          </p:nvSpPr>
          <p:spPr>
            <a:xfrm>
              <a:off x="5880240" y="1035000"/>
              <a:ext cx="144360" cy="727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18"/>
            <p:cNvSpPr/>
            <p:nvPr/>
          </p:nvSpPr>
          <p:spPr>
            <a:xfrm>
              <a:off x="5965200" y="812880"/>
              <a:ext cx="72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VE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19"/>
            <p:cNvSpPr/>
            <p:nvPr/>
          </p:nvSpPr>
          <p:spPr>
            <a:xfrm>
              <a:off x="5965200" y="966600"/>
              <a:ext cx="72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RT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TextBox 243"/>
          <p:cNvSpPr/>
          <p:nvPr/>
        </p:nvSpPr>
        <p:spPr>
          <a:xfrm flipH="1" rot="16200000">
            <a:off x="1996200" y="1339200"/>
            <a:ext cx="87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NZ" sz="1000" spc="-1" strike="noStrike">
                <a:solidFill>
                  <a:srgbClr val="000000"/>
                </a:solidFill>
                <a:latin typeface="Arial"/>
              </a:rPr>
              <a:t>% incre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80"/>
          <p:cNvSpPr/>
          <p:nvPr/>
        </p:nvSpPr>
        <p:spPr>
          <a:xfrm>
            <a:off x="189000" y="5161680"/>
            <a:ext cx="6453000" cy="246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: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TEMIN (ARTN) modulates anchorage-independent growth of estrogen receptor (ER) negative mammary carcinoma  (ER-MC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Monolayer proliferation assay. BT549-ARTN and MDA-MB-231-ARTN cells and their respective control cells were seeded in 2% FBS (serum) media. At the end of day 1, 2 and 3 cell viability was measured by alamar Blue. (B) Colony formation in soft agar. BT549-ARTN and MDA-MB-231-ARTN cells along with their respective vector (VEC) cells were cultured in 0.35% agar for 10 days. Cell growth was detected using alamarBlue. VEC cells are presented as 100%.(C) Monolayer proliferation assay. BT549-siARTN and MDA-MB-231-siARTN cells and their respective control (siCONT) cells were seeded in 2% FBS (serum) media. At the end of  day 1, 2 and 3 cell viability was measured by alamarBlue. (D) Colony formation in soft agar. BT549-siARTN and MDA-MB-231-siARTN cells along with their respective siCONT cells were cultured in 0.35% agar for 10 days. Cell growth was detected using alamarBlue. siCONT cells are presented as 100%.*, </a:t>
            </a:r>
            <a:r>
              <a:rPr b="0" i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0.05; **, </a:t>
            </a:r>
            <a:r>
              <a:rPr b="0" i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0.01;***, </a:t>
            </a:r>
            <a:r>
              <a:rPr b="0" i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0.00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43"/>
          <p:cNvSpPr/>
          <p:nvPr/>
        </p:nvSpPr>
        <p:spPr>
          <a:xfrm flipH="1" rot="16200000">
            <a:off x="3782520" y="1253880"/>
            <a:ext cx="175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Colony formation</a:t>
            </a:r>
            <a:r>
              <a:rPr b="1" lang="en-NZ" sz="1000" spc="-1" strike="noStrike">
                <a:solidFill>
                  <a:srgbClr val="000000"/>
                </a:solidFill>
                <a:latin typeface="Arial"/>
              </a:rPr>
              <a:t> ( 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41"/>
          <p:cNvSpPr/>
          <p:nvPr/>
        </p:nvSpPr>
        <p:spPr>
          <a:xfrm>
            <a:off x="4539600" y="2611440"/>
            <a:ext cx="194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Colony formation in soft ag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34"/>
          <p:cNvSpPr/>
          <p:nvPr/>
        </p:nvSpPr>
        <p:spPr>
          <a:xfrm>
            <a:off x="231840" y="2617920"/>
            <a:ext cx="158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Monolayer 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37"/>
          <p:cNvSpPr/>
          <p:nvPr/>
        </p:nvSpPr>
        <p:spPr>
          <a:xfrm>
            <a:off x="4317480" y="2611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37"/>
          <p:cNvSpPr/>
          <p:nvPr/>
        </p:nvSpPr>
        <p:spPr>
          <a:xfrm>
            <a:off x="47160" y="261792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0" name="Object 75"/>
          <p:cNvGraphicFramePr/>
          <p:nvPr/>
        </p:nvGraphicFramePr>
        <p:xfrm>
          <a:off x="4707000" y="3019320"/>
          <a:ext cx="1693800" cy="16131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81" name="Object 7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707000" y="3019320"/>
                    <a:ext cx="1693800" cy="1613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2" name="TextBox 168"/>
          <p:cNvSpPr/>
          <p:nvPr/>
        </p:nvSpPr>
        <p:spPr>
          <a:xfrm>
            <a:off x="4791240" y="3041640"/>
            <a:ext cx="186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           </a:t>
            </a: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BT549    MDA-MB-2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Group 68"/>
          <p:cNvGrpSpPr/>
          <p:nvPr/>
        </p:nvGrpSpPr>
        <p:grpSpPr>
          <a:xfrm>
            <a:off x="163440" y="2987640"/>
            <a:ext cx="2224080" cy="2025720"/>
            <a:chOff x="163440" y="2987640"/>
            <a:chExt cx="2224080" cy="2025720"/>
          </a:xfrm>
        </p:grpSpPr>
        <p:graphicFrame>
          <p:nvGraphicFramePr>
            <p:cNvPr id="84" name="Object 17"/>
            <p:cNvGraphicFramePr/>
            <p:nvPr/>
          </p:nvGraphicFramePr>
          <p:xfrm>
            <a:off x="249120" y="2987640"/>
            <a:ext cx="2138400" cy="202572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85" name="Object 17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249120" y="2987640"/>
                      <a:ext cx="2138400" cy="2025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6" name="TextBox 13"/>
            <p:cNvSpPr/>
            <p:nvPr/>
          </p:nvSpPr>
          <p:spPr>
            <a:xfrm>
              <a:off x="1363680" y="4018680"/>
              <a:ext cx="56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T54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243"/>
            <p:cNvSpPr/>
            <p:nvPr/>
          </p:nvSpPr>
          <p:spPr>
            <a:xfrm flipH="1" rot="16200000">
              <a:off x="-150840" y="3721680"/>
              <a:ext cx="875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incre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94"/>
            <p:cNvSpPr/>
            <p:nvPr/>
          </p:nvSpPr>
          <p:spPr>
            <a:xfrm>
              <a:off x="1589040" y="3306600"/>
              <a:ext cx="355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2316240" y="2984400"/>
            <a:ext cx="2254320" cy="2025720"/>
            <a:chOff x="2316240" y="2984400"/>
            <a:chExt cx="2254320" cy="2025720"/>
          </a:xfrm>
        </p:grpSpPr>
        <p:graphicFrame>
          <p:nvGraphicFramePr>
            <p:cNvPr id="90" name="Object 73"/>
            <p:cNvGraphicFramePr/>
            <p:nvPr/>
          </p:nvGraphicFramePr>
          <p:xfrm>
            <a:off x="2433600" y="2984400"/>
            <a:ext cx="2136960" cy="202572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91" name="Object 73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2433600" y="2984400"/>
                      <a:ext cx="2136960" cy="2025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2" name="TextBox 13"/>
            <p:cNvSpPr/>
            <p:nvPr/>
          </p:nvSpPr>
          <p:spPr>
            <a:xfrm>
              <a:off x="3330360" y="4023720"/>
              <a:ext cx="996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DA-MB-23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243"/>
            <p:cNvSpPr/>
            <p:nvPr/>
          </p:nvSpPr>
          <p:spPr>
            <a:xfrm flipH="1" rot="16200000">
              <a:off x="2001600" y="3714120"/>
              <a:ext cx="875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incre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Box 94"/>
            <p:cNvSpPr/>
            <p:nvPr/>
          </p:nvSpPr>
          <p:spPr>
            <a:xfrm>
              <a:off x="3749760" y="3163320"/>
              <a:ext cx="355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TextBox 243"/>
          <p:cNvSpPr/>
          <p:nvPr/>
        </p:nvSpPr>
        <p:spPr>
          <a:xfrm flipH="1" rot="16200000">
            <a:off x="3797280" y="3638520"/>
            <a:ext cx="175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Colony formation </a:t>
            </a:r>
            <a:r>
              <a:rPr b="1" lang="en-NZ" sz="1000" spc="-1" strike="noStrike">
                <a:solidFill>
                  <a:srgbClr val="000000"/>
                </a:solidFill>
                <a:latin typeface="Arial"/>
              </a:rPr>
              <a:t> ( 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Group 168"/>
          <p:cNvGrpSpPr/>
          <p:nvPr/>
        </p:nvGrpSpPr>
        <p:grpSpPr>
          <a:xfrm>
            <a:off x="5999040" y="3571920"/>
            <a:ext cx="835200" cy="399600"/>
            <a:chOff x="5999040" y="3571920"/>
            <a:chExt cx="835200" cy="399600"/>
          </a:xfrm>
        </p:grpSpPr>
        <p:sp>
          <p:nvSpPr>
            <p:cNvPr id="97" name="Rectangle 100"/>
            <p:cNvSpPr/>
            <p:nvPr/>
          </p:nvSpPr>
          <p:spPr>
            <a:xfrm>
              <a:off x="5999040" y="3662280"/>
              <a:ext cx="144360" cy="7128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01"/>
            <p:cNvSpPr/>
            <p:nvPr/>
          </p:nvSpPr>
          <p:spPr>
            <a:xfrm>
              <a:off x="5999040" y="3801960"/>
              <a:ext cx="144360" cy="727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18"/>
            <p:cNvSpPr/>
            <p:nvPr/>
          </p:nvSpPr>
          <p:spPr>
            <a:xfrm>
              <a:off x="6084000" y="3571920"/>
              <a:ext cx="720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CO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19"/>
            <p:cNvSpPr/>
            <p:nvPr/>
          </p:nvSpPr>
          <p:spPr>
            <a:xfrm>
              <a:off x="6112440" y="3725280"/>
              <a:ext cx="72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N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ART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TextBox 94"/>
          <p:cNvSpPr/>
          <p:nvPr/>
        </p:nvSpPr>
        <p:spPr>
          <a:xfrm>
            <a:off x="1547640" y="808200"/>
            <a:ext cx="452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1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94"/>
          <p:cNvSpPr/>
          <p:nvPr/>
        </p:nvSpPr>
        <p:spPr>
          <a:xfrm>
            <a:off x="3781440" y="849240"/>
            <a:ext cx="355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1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Straight Connector 106"/>
          <p:cNvSpPr/>
          <p:nvPr/>
        </p:nvSpPr>
        <p:spPr>
          <a:xfrm>
            <a:off x="5683320" y="3187800"/>
            <a:ext cx="7920" cy="137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ight Bracket 107"/>
          <p:cNvSpPr/>
          <p:nvPr/>
        </p:nvSpPr>
        <p:spPr>
          <a:xfrm rot="16200000">
            <a:off x="5968080" y="3409200"/>
            <a:ext cx="84240" cy="317520"/>
          </a:xfrm>
          <a:custGeom>
            <a:avLst/>
            <a:gdLst>
              <a:gd name="textAreaLeft" fmla="*/ 0 w 84240"/>
              <a:gd name="textAreaRight" fmla="*/ 59040 w 84240"/>
              <a:gd name="textAreaTop" fmla="*/ 3240 h 317520"/>
              <a:gd name="textAreaBottom" fmla="*/ 314280 h 317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239"/>
                  <a:pt x="21600" y="477"/>
                </a:cubicBezTo>
                <a:lnTo>
                  <a:pt x="21600" y="21123"/>
                </a:lnTo>
                <a:cubicBezTo>
                  <a:pt x="21600" y="21362"/>
                  <a:pt x="108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94"/>
          <p:cNvSpPr/>
          <p:nvPr/>
        </p:nvSpPr>
        <p:spPr>
          <a:xfrm>
            <a:off x="5202000" y="3408480"/>
            <a:ext cx="27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ight Bracket 109"/>
          <p:cNvSpPr/>
          <p:nvPr/>
        </p:nvSpPr>
        <p:spPr>
          <a:xfrm rot="16200000">
            <a:off x="5330160" y="3393360"/>
            <a:ext cx="55440" cy="365040"/>
          </a:xfrm>
          <a:custGeom>
            <a:avLst/>
            <a:gdLst>
              <a:gd name="textAreaLeft" fmla="*/ 0 w 55440"/>
              <a:gd name="textAreaRight" fmla="*/ 38880 w 55440"/>
              <a:gd name="textAreaTop" fmla="*/ 2160 h 365040"/>
              <a:gd name="textAreaBottom" fmla="*/ 362880 h 365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37"/>
                  <a:pt x="21600" y="274"/>
                </a:cubicBezTo>
                <a:lnTo>
                  <a:pt x="21600" y="21326"/>
                </a:lnTo>
                <a:cubicBezTo>
                  <a:pt x="21600" y="21463"/>
                  <a:pt x="108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94"/>
          <p:cNvSpPr/>
          <p:nvPr/>
        </p:nvSpPr>
        <p:spPr>
          <a:xfrm>
            <a:off x="5892480" y="3387600"/>
            <a:ext cx="27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6T23:04:05Z</dcterms:created>
  <dc:creator>Uni User</dc:creator>
  <dc:description/>
  <dc:language>en-US</dc:language>
  <cp:lastModifiedBy>arunima</cp:lastModifiedBy>
  <dcterms:modified xsi:type="dcterms:W3CDTF">2011-11-22T05:56:15Z</dcterms:modified>
  <cp:revision>1060</cp:revision>
  <dc:subject/>
  <dc:title>Slide 1</dc:title>
</cp:coreProperties>
</file>